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9" d="100"/>
          <a:sy n="79" d="100"/>
        </p:scale>
        <p:origin x="3024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328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560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943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654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36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636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365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068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882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591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375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21AC0B-4DD5-4566-9990-17BA2AFF8B6A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5BE623-12E0-45AB-AA26-68278194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232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35F806-C88E-45C1-B583-72D8344CE279}"/>
              </a:ext>
            </a:extLst>
          </p:cNvPr>
          <p:cNvSpPr txBox="1"/>
          <p:nvPr/>
        </p:nvSpPr>
        <p:spPr>
          <a:xfrm>
            <a:off x="158304" y="4180734"/>
            <a:ext cx="6541392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Development of DOCA-salt hypertension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mean arterial pressure was measured by telemetry transmitters in male wild-type mice with sham or DOCA-salt treatment (1 mg/g body weight DOCA, 1% NaCl for 21 days). The DOCA-salt treatment resulted in significant increase in mean arterial pressure from the day 7 and remained elevated at days 14 and 21. n=4-8 mice/group, *P&lt;0.01 vs. Sham.</a:t>
            </a:r>
          </a:p>
        </p:txBody>
      </p:sp>
      <p:pic>
        <p:nvPicPr>
          <p:cNvPr id="3" name="Picture 2" descr="Chart, line chart&#10;&#10;Description automatically generated">
            <a:extLst>
              <a:ext uri="{FF2B5EF4-FFF2-40B4-BE49-F238E27FC236}">
                <a16:creationId xmlns:a16="http://schemas.microsoft.com/office/drawing/2014/main" id="{1E0E0FEE-5851-4434-9C89-51EA04FAC0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636" y="1394862"/>
            <a:ext cx="4818888" cy="27249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8961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116600FC-7C12-40EB-A096-249999B7F9E0}"/>
              </a:ext>
            </a:extLst>
          </p:cNvPr>
          <p:cNvSpPr txBox="1"/>
          <p:nvPr/>
        </p:nvSpPr>
        <p:spPr>
          <a:xfrm>
            <a:off x="169523" y="6853279"/>
            <a:ext cx="6541392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B1R stimulation increased the expression of fibrosis and kidney injury markers in human kidney proximal tubular epithelial (HK-2) 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cells.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hotomicrographs showing immunofluorescence of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SMA, fibronectin and Kim-1 in HK-2 cells treated with vehicle or B1R specific agonist, Des-Arg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Kallidin (DAKD) for 24 hrs. </a:t>
            </a:r>
          </a:p>
        </p:txBody>
      </p:sp>
      <p:pic>
        <p:nvPicPr>
          <p:cNvPr id="3" name="Picture 2" descr="Background pattern&#10;&#10;Description automatically generated">
            <a:extLst>
              <a:ext uri="{FF2B5EF4-FFF2-40B4-BE49-F238E27FC236}">
                <a16:creationId xmlns:a16="http://schemas.microsoft.com/office/drawing/2014/main" id="{2E4CD602-DA11-4C3A-A83C-2A52EAF81D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9670" y="853020"/>
            <a:ext cx="4518660" cy="5884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5890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</TotalTime>
  <Words>138</Words>
  <Application>Microsoft Office PowerPoint</Application>
  <PresentationFormat>Letter Paper (8.5x11 in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ramula, Srinivas</dc:creator>
  <cp:lastModifiedBy>Sriramula, Srinivas</cp:lastModifiedBy>
  <cp:revision>12</cp:revision>
  <dcterms:created xsi:type="dcterms:W3CDTF">2021-09-16T19:25:17Z</dcterms:created>
  <dcterms:modified xsi:type="dcterms:W3CDTF">2021-11-17T15:57:04Z</dcterms:modified>
</cp:coreProperties>
</file>